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15" autoAdjust="0"/>
    <p:restoredTop sz="94660"/>
  </p:normalViewPr>
  <p:slideViewPr>
    <p:cSldViewPr snapToGrid="0">
      <p:cViewPr varScale="1">
        <p:scale>
          <a:sx n="74" d="100"/>
          <a:sy n="74" d="100"/>
        </p:scale>
        <p:origin x="49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5A7CE-A800-4979-9E2E-9ADBEF159086}" type="datetimeFigureOut">
              <a:rPr lang="it-IT" smtClean="0"/>
              <a:t>19/01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8DD0EE-ED45-4CC1-A574-C615B7AEFC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37522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5A7CE-A800-4979-9E2E-9ADBEF159086}" type="datetimeFigureOut">
              <a:rPr lang="it-IT" smtClean="0"/>
              <a:t>19/01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8DD0EE-ED45-4CC1-A574-C615B7AEFC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520661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5A7CE-A800-4979-9E2E-9ADBEF159086}" type="datetimeFigureOut">
              <a:rPr lang="it-IT" smtClean="0"/>
              <a:t>19/01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8DD0EE-ED45-4CC1-A574-C615B7AEFC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18164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5A7CE-A800-4979-9E2E-9ADBEF159086}" type="datetimeFigureOut">
              <a:rPr lang="it-IT" smtClean="0"/>
              <a:t>19/01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8DD0EE-ED45-4CC1-A574-C615B7AEFC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86416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5A7CE-A800-4979-9E2E-9ADBEF159086}" type="datetimeFigureOut">
              <a:rPr lang="it-IT" smtClean="0"/>
              <a:t>19/01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8DD0EE-ED45-4CC1-A574-C615B7AEFC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928142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5A7CE-A800-4979-9E2E-9ADBEF159086}" type="datetimeFigureOut">
              <a:rPr lang="it-IT" smtClean="0"/>
              <a:t>19/01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8DD0EE-ED45-4CC1-A574-C615B7AEFC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574186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5A7CE-A800-4979-9E2E-9ADBEF159086}" type="datetimeFigureOut">
              <a:rPr lang="it-IT" smtClean="0"/>
              <a:t>19/01/2021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8DD0EE-ED45-4CC1-A574-C615B7AEFC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528297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5A7CE-A800-4979-9E2E-9ADBEF159086}" type="datetimeFigureOut">
              <a:rPr lang="it-IT" smtClean="0"/>
              <a:t>19/01/2021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8DD0EE-ED45-4CC1-A574-C615B7AEFC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28749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5A7CE-A800-4979-9E2E-9ADBEF159086}" type="datetimeFigureOut">
              <a:rPr lang="it-IT" smtClean="0"/>
              <a:t>19/01/2021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8DD0EE-ED45-4CC1-A574-C615B7AEFC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365045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5A7CE-A800-4979-9E2E-9ADBEF159086}" type="datetimeFigureOut">
              <a:rPr lang="it-IT" smtClean="0"/>
              <a:t>19/01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8DD0EE-ED45-4CC1-A574-C615B7AEFC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853588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5A7CE-A800-4979-9E2E-9ADBEF159086}" type="datetimeFigureOut">
              <a:rPr lang="it-IT" smtClean="0"/>
              <a:t>19/01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8DD0EE-ED45-4CC1-A574-C615B7AEFC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984004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A5A7CE-A800-4979-9E2E-9ADBEF159086}" type="datetimeFigureOut">
              <a:rPr lang="it-IT" smtClean="0"/>
              <a:t>19/01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8DD0EE-ED45-4CC1-A574-C615B7AEFC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309030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1624454" y="4727393"/>
            <a:ext cx="850485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69875" marR="269875" algn="just">
              <a:spcBef>
                <a:spcPts val="600"/>
              </a:spcBef>
              <a:spcAft>
                <a:spcPts val="1200"/>
              </a:spcAft>
            </a:pPr>
            <a:r>
              <a:rPr lang="en-US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1. </a:t>
            </a:r>
            <a:r>
              <a:rPr lang="en-US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rowth of </a:t>
            </a:r>
            <a:r>
              <a:rPr lang="en-US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. </a:t>
            </a:r>
            <a:r>
              <a:rPr lang="en-US" i="1" dirty="0" err="1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ruloides</a:t>
            </a:r>
            <a:r>
              <a:rPr lang="en-US" i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n synthetic media at pH 3.5 (panel A) and pH 5.5. 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ular dry weight (CDW) in dashed line, total sugars in dotted </a:t>
            </a:r>
            <a:r>
              <a:rPr lang="en-US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ne. 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alues are the means of three independent experiments</a:t>
            </a:r>
            <a:r>
              <a:rPr lang="en-US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it-IT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2"/>
          <a:srcRect b="8391"/>
          <a:stretch/>
        </p:blipFill>
        <p:spPr>
          <a:xfrm>
            <a:off x="1618550" y="2091286"/>
            <a:ext cx="8510754" cy="26361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12973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37300" y="2041328"/>
            <a:ext cx="4289466" cy="2758437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130063" y="4799765"/>
            <a:ext cx="85048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69875" marR="269875" algn="just">
              <a:spcBef>
                <a:spcPts val="600"/>
              </a:spcBef>
              <a:spcAft>
                <a:spcPts val="1200"/>
              </a:spcAft>
            </a:pPr>
            <a:r>
              <a:rPr lang="en-US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2. </a:t>
            </a:r>
            <a:r>
              <a:rPr lang="en-US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mmonium titer during </a:t>
            </a:r>
            <a:r>
              <a:rPr lang="en-US" i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i="1" dirty="0" err="1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ruloides</a:t>
            </a:r>
            <a:r>
              <a:rPr lang="en-US" i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rowth on C-PEW hydrolysate. 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alues are the means of three independent experiments</a:t>
            </a:r>
            <a:r>
              <a:rPr lang="en-US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it-IT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684215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</TotalTime>
  <Words>70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5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Times New Roman</vt:lpstr>
      <vt:lpstr>Office Theme</vt:lpstr>
      <vt:lpstr>Presentazione standard di PowerPoint</vt:lpstr>
      <vt:lpstr>Presentazione standard di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.bertacchi@campus.unimib.it</dc:creator>
  <cp:lastModifiedBy>Account Microsoft</cp:lastModifiedBy>
  <cp:revision>3</cp:revision>
  <dcterms:created xsi:type="dcterms:W3CDTF">2021-01-19T13:29:17Z</dcterms:created>
  <dcterms:modified xsi:type="dcterms:W3CDTF">2021-01-19T15:51:36Z</dcterms:modified>
</cp:coreProperties>
</file>